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6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850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5D49E7B-6F75-DC6C-F690-428135B1BDF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E8DB842F-6418-70BE-46FD-2FB5245F8F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6C1F5EB-D311-31FE-0ECF-A1CBEACC20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9DB11-5E2E-4D59-9E7B-3856CC19971B}" type="datetimeFigureOut">
              <a:rPr lang="es-ES" smtClean="0"/>
              <a:t>17/04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2DBA6DB-6697-1874-97DF-8E83EC1012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713AC8F-88D6-96E1-6472-8EEB5DD32E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D287F-4FA2-45F1-B0B8-762173ACB6A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97331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97FB29F-FBB9-87F1-6456-672065F896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A324D1F-D06A-7594-C936-BF3FDFDAF6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8C57389-51A0-B998-AB28-44D97A2E9B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9DB11-5E2E-4D59-9E7B-3856CC19971B}" type="datetimeFigureOut">
              <a:rPr lang="es-ES" smtClean="0"/>
              <a:t>17/04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A6B4904-7B34-29CE-D5C5-F481C57B00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2527B2E-F6E6-9ED9-B1AD-1C407CA49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D287F-4FA2-45F1-B0B8-762173ACB6A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46288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A5DC19AF-D177-CCBE-578F-B871374D4B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76C91FF-3B02-6A42-64F7-FC477A05DB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8BDDF81-CABD-0329-55C0-20D5BA8013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9DB11-5E2E-4D59-9E7B-3856CC19971B}" type="datetimeFigureOut">
              <a:rPr lang="es-ES" smtClean="0"/>
              <a:t>17/04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3C108F0-7DEF-F795-7DFC-40EAA0B065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33692C6-C5C8-5A8D-D62E-7C0135473D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D287F-4FA2-45F1-B0B8-762173ACB6A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1399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2B37B08-BD10-C5C7-DD8A-ADF5261D39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D6211A8-8101-AB74-0A06-C211845D56C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079F4DE-A183-8B39-0413-0A3A6FAF9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9DB11-5E2E-4D59-9E7B-3856CC19971B}" type="datetimeFigureOut">
              <a:rPr lang="es-ES" smtClean="0"/>
              <a:t>17/04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09C09AD-A419-AB4F-26BC-D75F1C071F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689C2AA-EABC-F3F1-B944-5A62099725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D287F-4FA2-45F1-B0B8-762173ACB6A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43557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D587629-CC70-82D5-B0E7-2E245DACCD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66CC95E-8FBB-230B-A494-F4874171B1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CF93D9B-3E88-E3E8-7747-01C2D5B9C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9DB11-5E2E-4D59-9E7B-3856CC19971B}" type="datetimeFigureOut">
              <a:rPr lang="es-ES" smtClean="0"/>
              <a:t>17/04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A615570-6E7F-6308-FED2-97310D0696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A4FF82B-74EE-8BA0-B760-322B454A0E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D287F-4FA2-45F1-B0B8-762173ACB6A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4108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AEC5118-1934-35C7-C2A2-12DFE330C3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FD435FD-DE06-00C0-F9AD-334BE00AD2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5E6D04B-C97F-1FC7-6175-5211673EBD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9244A24-E2B0-6993-9D87-D4285EB67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9DB11-5E2E-4D59-9E7B-3856CC19971B}" type="datetimeFigureOut">
              <a:rPr lang="es-ES" smtClean="0"/>
              <a:t>17/04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2C1A06C-58F7-8470-9285-0FC760606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54C29EB-8071-B9ED-B49E-EA11E39B95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D287F-4FA2-45F1-B0B8-762173ACB6A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291927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0073D9E-EBA6-DBC4-79C1-76349508A5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2FD47AE-16E3-9AFD-D019-87CC5FB449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05217A1-176B-B5F4-40B5-712156D516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D151D98F-FF0C-AF98-EBB4-51ED1763E8C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0C15435B-B83E-C088-BDE0-DF9A7BEABA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E0CE2ACF-EFE5-88E6-4BED-6260A6258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9DB11-5E2E-4D59-9E7B-3856CC19971B}" type="datetimeFigureOut">
              <a:rPr lang="es-ES" smtClean="0"/>
              <a:t>17/04/2024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F60A3435-C708-D801-C212-B1494AF39C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26D3D472-B96E-FC41-0E31-511659808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D287F-4FA2-45F1-B0B8-762173ACB6A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6216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53CCC2D-3325-2780-92D8-5686E23A2E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8EA7383F-8F07-B0EF-528C-4598CA6553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9DB11-5E2E-4D59-9E7B-3856CC19971B}" type="datetimeFigureOut">
              <a:rPr lang="es-ES" smtClean="0"/>
              <a:t>17/04/2024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0910B357-C762-3298-C380-EF8864332F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013590BF-5D25-E97D-1546-EBF9844465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D287F-4FA2-45F1-B0B8-762173ACB6A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6752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7241209F-AB2B-E597-2C36-EED48D19A3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9DB11-5E2E-4D59-9E7B-3856CC19971B}" type="datetimeFigureOut">
              <a:rPr lang="es-ES" smtClean="0"/>
              <a:t>17/04/2024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21EB90F2-C741-7B65-8968-8F284396A3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451300E1-FA64-7900-6EF7-4D380D9AA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D287F-4FA2-45F1-B0B8-762173ACB6A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82318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018A431-9EE2-9F79-CFE9-1374EAD5F1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565C88D-362A-EFE0-2B86-D1989BE4FA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F2278BC8-2331-DE4E-8B42-BFAEE9E8CB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35E7353-5B99-A1F6-F3A3-013CFDC98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9DB11-5E2E-4D59-9E7B-3856CC19971B}" type="datetimeFigureOut">
              <a:rPr lang="es-ES" smtClean="0"/>
              <a:t>17/04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6AEDF68-C722-FBA7-6A0B-62AE4957F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9BD4D38-FE14-5D54-34E8-91C056919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D287F-4FA2-45F1-B0B8-762173ACB6A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4005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F9ED205-A251-9C42-9B95-A9030EC2C6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01B1AA09-0217-5861-83F6-70D4426F08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536FB06-1A64-C8BB-AEC1-A6E713BD2F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72982AE-CC85-8213-FB39-AAD129348E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9DB11-5E2E-4D59-9E7B-3856CC19971B}" type="datetimeFigureOut">
              <a:rPr lang="es-ES" smtClean="0"/>
              <a:t>17/04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0CDECAD-9FE0-5CC3-EBEA-A51B985399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4EBA141-91E1-55B7-CBB7-1AF32AC81F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D287F-4FA2-45F1-B0B8-762173ACB6A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72132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AD9A1E2F-AB7F-FEF9-22F6-FAA660AD66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0FB4F3D-B8A4-78BA-8C53-D698FF24FC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83DFACA-F499-73EC-32FF-8E49FDAFC80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99DB11-5E2E-4D59-9E7B-3856CC19971B}" type="datetimeFigureOut">
              <a:rPr lang="es-ES" smtClean="0"/>
              <a:t>17/04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81A7AA3-F547-F01D-70A0-1A4FA8A4DB2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8940F45-668D-FC5C-E33F-5F090AF898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BD287F-4FA2-45F1-B0B8-762173ACB6A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4046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F36F0585-7E2D-6A0C-A05B-5CC6F726E7EA}"/>
              </a:ext>
            </a:extLst>
          </p:cNvPr>
          <p:cNvGrpSpPr/>
          <p:nvPr/>
        </p:nvGrpSpPr>
        <p:grpSpPr>
          <a:xfrm>
            <a:off x="3580638" y="1029370"/>
            <a:ext cx="5030724" cy="4244381"/>
            <a:chOff x="3580638" y="1029370"/>
            <a:chExt cx="5030724" cy="4244381"/>
          </a:xfrm>
        </p:grpSpPr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791AB726-36BB-F87C-929F-F4DB2B3F72C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80638" y="1029370"/>
              <a:ext cx="5030724" cy="3561588"/>
            </a:xfrm>
            <a:prstGeom prst="rect">
              <a:avLst/>
            </a:prstGeom>
          </p:spPr>
        </p:pic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8D86C7F7-D7E1-8608-0C53-A4CBE1DDFA3E}"/>
                </a:ext>
              </a:extLst>
            </p:cNvPr>
            <p:cNvSpPr txBox="1"/>
            <p:nvPr/>
          </p:nvSpPr>
          <p:spPr>
            <a:xfrm>
              <a:off x="3580638" y="4627420"/>
              <a:ext cx="503072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s-ES" sz="1200" b="1" dirty="0" err="1"/>
                <a:t>Supplementary</a:t>
              </a:r>
              <a:r>
                <a:rPr lang="es-ES" sz="1200" b="1" dirty="0"/>
                <a:t> Figure S1. </a:t>
              </a:r>
              <a:r>
                <a:rPr lang="es-ES" sz="1200" dirty="0" err="1"/>
                <a:t>Main</a:t>
              </a:r>
              <a:r>
                <a:rPr lang="es-ES" sz="1200" dirty="0"/>
                <a:t> </a:t>
              </a:r>
              <a:r>
                <a:rPr lang="es-ES" sz="1200" dirty="0" err="1"/>
                <a:t>orchestrators</a:t>
              </a:r>
              <a:r>
                <a:rPr lang="es-ES" sz="1200" dirty="0"/>
                <a:t> </a:t>
              </a:r>
              <a:r>
                <a:rPr lang="es-ES" sz="1200" dirty="0" err="1"/>
                <a:t>of</a:t>
              </a:r>
              <a:r>
                <a:rPr lang="es-ES" sz="1200" dirty="0"/>
                <a:t> </a:t>
              </a:r>
              <a:r>
                <a:rPr lang="es-ES" sz="1200" dirty="0" err="1"/>
                <a:t>the</a:t>
              </a:r>
              <a:r>
                <a:rPr lang="es-ES" sz="1200" dirty="0"/>
                <a:t> epitelial-</a:t>
              </a:r>
              <a:r>
                <a:rPr lang="es-ES" sz="1200" dirty="0" err="1"/>
                <a:t>mesenchymal</a:t>
              </a:r>
              <a:r>
                <a:rPr lang="es-ES" sz="1200" dirty="0"/>
                <a:t> </a:t>
              </a:r>
              <a:r>
                <a:rPr lang="es-ES" sz="1200" dirty="0" err="1"/>
                <a:t>transition</a:t>
              </a:r>
              <a:r>
                <a:rPr lang="es-ES" sz="1200" dirty="0"/>
                <a:t> (EMT) </a:t>
              </a:r>
              <a:r>
                <a:rPr lang="es-ES" sz="1200" dirty="0" err="1"/>
                <a:t>process</a:t>
              </a:r>
              <a:r>
                <a:rPr lang="es-ES" sz="1200" dirty="0"/>
                <a:t> and </a:t>
              </a:r>
              <a:r>
                <a:rPr lang="es-ES" sz="1200" dirty="0" err="1"/>
                <a:t>associated</a:t>
              </a:r>
              <a:r>
                <a:rPr lang="es-ES" sz="1200" dirty="0"/>
                <a:t> </a:t>
              </a:r>
              <a:r>
                <a:rPr lang="es-ES" sz="1200" dirty="0" err="1"/>
                <a:t>triggering</a:t>
              </a:r>
              <a:r>
                <a:rPr lang="es-ES" sz="1200" dirty="0"/>
                <a:t> </a:t>
              </a:r>
              <a:r>
                <a:rPr lang="es-ES" sz="1200" dirty="0" err="1"/>
                <a:t>signaling</a:t>
              </a:r>
              <a:r>
                <a:rPr lang="es-ES" sz="1200" dirty="0"/>
                <a:t> </a:t>
              </a:r>
              <a:r>
                <a:rPr lang="es-ES" sz="1200" dirty="0" err="1"/>
                <a:t>pathways</a:t>
              </a:r>
              <a:r>
                <a:rPr lang="es-ES" sz="1200" dirty="0"/>
                <a:t>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465686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rancisco Artacho Cordón</dc:creator>
  <cp:lastModifiedBy>MDPI</cp:lastModifiedBy>
  <cp:revision>3</cp:revision>
  <dcterms:created xsi:type="dcterms:W3CDTF">2024-04-12T07:45:17Z</dcterms:created>
  <dcterms:modified xsi:type="dcterms:W3CDTF">2024-04-17T12:40:46Z</dcterms:modified>
</cp:coreProperties>
</file>